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  <p:sldId id="257" r:id="rId6"/>
    <p:sldId id="258" r:id="rId7"/>
    <p:sldId id="278" r:id="rId8"/>
    <p:sldId id="279" r:id="rId9"/>
    <p:sldId id="277" r:id="rId10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6" autoAdjust="0"/>
    <p:restoredTop sz="94660"/>
  </p:normalViewPr>
  <p:slideViewPr>
    <p:cSldViewPr snapToGrid="0">
      <p:cViewPr varScale="1">
        <p:scale>
          <a:sx n="159" d="100"/>
          <a:sy n="159" d="100"/>
        </p:scale>
        <p:origin x="506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BE2B6-E9F5-4B01-A282-189493EA3F4D}" type="datetimeFigureOut">
              <a:rPr lang="en-US" smtClean="0"/>
              <a:t>5/1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FB4A2-E4B7-4AA4-9C73-F70E6F6A3A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62172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BE2B6-E9F5-4B01-A282-189493EA3F4D}" type="datetimeFigureOut">
              <a:rPr lang="en-US" smtClean="0"/>
              <a:t>5/1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FB4A2-E4B7-4AA4-9C73-F70E6F6A3A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2981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BE2B6-E9F5-4B01-A282-189493EA3F4D}" type="datetimeFigureOut">
              <a:rPr lang="en-US" smtClean="0"/>
              <a:t>5/1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FB4A2-E4B7-4AA4-9C73-F70E6F6A3A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86471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BE2B6-E9F5-4B01-A282-189493EA3F4D}" type="datetimeFigureOut">
              <a:rPr lang="en-US" smtClean="0"/>
              <a:t>5/1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FB4A2-E4B7-4AA4-9C73-F70E6F6A3A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1864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BE2B6-E9F5-4B01-A282-189493EA3F4D}" type="datetimeFigureOut">
              <a:rPr lang="en-US" smtClean="0"/>
              <a:t>5/1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FB4A2-E4B7-4AA4-9C73-F70E6F6A3A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2963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BE2B6-E9F5-4B01-A282-189493EA3F4D}" type="datetimeFigureOut">
              <a:rPr lang="en-US" smtClean="0"/>
              <a:t>5/1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FB4A2-E4B7-4AA4-9C73-F70E6F6A3A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60463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BE2B6-E9F5-4B01-A282-189493EA3F4D}" type="datetimeFigureOut">
              <a:rPr lang="en-US" smtClean="0"/>
              <a:t>5/13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FB4A2-E4B7-4AA4-9C73-F70E6F6A3A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66563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BE2B6-E9F5-4B01-A282-189493EA3F4D}" type="datetimeFigureOut">
              <a:rPr lang="en-US" smtClean="0"/>
              <a:t>5/13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FB4A2-E4B7-4AA4-9C73-F70E6F6A3A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26139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BE2B6-E9F5-4B01-A282-189493EA3F4D}" type="datetimeFigureOut">
              <a:rPr lang="en-US" smtClean="0"/>
              <a:t>5/13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FB4A2-E4B7-4AA4-9C73-F70E6F6A3A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57297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BE2B6-E9F5-4B01-A282-189493EA3F4D}" type="datetimeFigureOut">
              <a:rPr lang="en-US" smtClean="0"/>
              <a:t>5/1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FB4A2-E4B7-4AA4-9C73-F70E6F6A3A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79766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BE2B6-E9F5-4B01-A282-189493EA3F4D}" type="datetimeFigureOut">
              <a:rPr lang="en-US" smtClean="0"/>
              <a:t>5/1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FB4A2-E4B7-4AA4-9C73-F70E6F6A3A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72716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CBE2B6-E9F5-4B01-A282-189493EA3F4D}" type="datetimeFigureOut">
              <a:rPr lang="en-US" smtClean="0"/>
              <a:t>5/1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9FB4A2-E4B7-4AA4-9C73-F70E6F6A3A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61223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7" Type="http://schemas.openxmlformats.org/officeDocument/2006/relationships/image" Target="../media/image17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>
            <a:extLst>
              <a:ext uri="{FF2B5EF4-FFF2-40B4-BE49-F238E27FC236}">
                <a16:creationId xmlns:a16="http://schemas.microsoft.com/office/drawing/2014/main" id="{7889EA8C-0C22-4AF9-8BF1-F8C53CEF9021}"/>
              </a:ext>
            </a:extLst>
          </p:cNvPr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13009" y="541204"/>
            <a:ext cx="201168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2" name="Picture 8">
            <a:extLst>
              <a:ext uri="{FF2B5EF4-FFF2-40B4-BE49-F238E27FC236}">
                <a16:creationId xmlns:a16="http://schemas.microsoft.com/office/drawing/2014/main" id="{1D99E0C0-597F-43FE-A5EF-1DCA2AE0B6B1}"/>
              </a:ext>
            </a:extLst>
          </p:cNvPr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84357" y="528847"/>
            <a:ext cx="201168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4" name="Picture 10">
            <a:extLst>
              <a:ext uri="{FF2B5EF4-FFF2-40B4-BE49-F238E27FC236}">
                <a16:creationId xmlns:a16="http://schemas.microsoft.com/office/drawing/2014/main" id="{CBFC9F7B-165D-4639-8CD6-C862D66D5536}"/>
              </a:ext>
            </a:extLst>
          </p:cNvPr>
          <p:cNvPicPr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5621" y="2197002"/>
            <a:ext cx="201168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6" name="Picture 12">
            <a:extLst>
              <a:ext uri="{FF2B5EF4-FFF2-40B4-BE49-F238E27FC236}">
                <a16:creationId xmlns:a16="http://schemas.microsoft.com/office/drawing/2014/main" id="{8B93E6F7-EE40-4ECA-B821-AAC81AFB5B42}"/>
              </a:ext>
            </a:extLst>
          </p:cNvPr>
          <p:cNvPicPr>
            <a:picLocks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4627607" y="2187122"/>
            <a:ext cx="201168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5913B70-9B39-4C0A-A7DF-1FD562AB03F2}"/>
              </a:ext>
            </a:extLst>
          </p:cNvPr>
          <p:cNvSpPr txBox="1"/>
          <p:nvPr/>
        </p:nvSpPr>
        <p:spPr>
          <a:xfrm>
            <a:off x="218713" y="1508172"/>
            <a:ext cx="19169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MCF-7 45m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960AA43-61CC-47A8-87C3-81F75474EE17}"/>
              </a:ext>
            </a:extLst>
          </p:cNvPr>
          <p:cNvSpPr txBox="1"/>
          <p:nvPr/>
        </p:nvSpPr>
        <p:spPr>
          <a:xfrm>
            <a:off x="218713" y="4342202"/>
            <a:ext cx="189429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Primary hepatocytes</a:t>
            </a:r>
          </a:p>
        </p:txBody>
      </p:sp>
      <p:pic>
        <p:nvPicPr>
          <p:cNvPr id="1038" name="Picture 14">
            <a:extLst>
              <a:ext uri="{FF2B5EF4-FFF2-40B4-BE49-F238E27FC236}">
                <a16:creationId xmlns:a16="http://schemas.microsoft.com/office/drawing/2014/main" id="{79B90A3F-45BE-47D4-BDB3-009E39CDDCC6}"/>
              </a:ext>
            </a:extLst>
          </p:cNvPr>
          <p:cNvPicPr>
            <a:picLocks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13009" y="3904651"/>
            <a:ext cx="201168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0" name="Picture 16">
            <a:extLst>
              <a:ext uri="{FF2B5EF4-FFF2-40B4-BE49-F238E27FC236}">
                <a16:creationId xmlns:a16="http://schemas.microsoft.com/office/drawing/2014/main" id="{E8E9F72D-2ADB-4ADA-9A07-DEBC24E95E52}"/>
              </a:ext>
            </a:extLst>
          </p:cNvPr>
          <p:cNvPicPr>
            <a:picLocks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2063" y="3892294"/>
            <a:ext cx="201168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5E755622-AB32-404D-8925-BAD3437A44E8}"/>
              </a:ext>
            </a:extLst>
          </p:cNvPr>
          <p:cNvSpPr txBox="1"/>
          <p:nvPr/>
        </p:nvSpPr>
        <p:spPr>
          <a:xfrm>
            <a:off x="218713" y="2784852"/>
            <a:ext cx="191690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MCF-7 45m w/o ARNT 45m</a:t>
            </a:r>
          </a:p>
        </p:txBody>
      </p:sp>
      <p:pic>
        <p:nvPicPr>
          <p:cNvPr id="1042" name="Picture 18">
            <a:extLst>
              <a:ext uri="{FF2B5EF4-FFF2-40B4-BE49-F238E27FC236}">
                <a16:creationId xmlns:a16="http://schemas.microsoft.com/office/drawing/2014/main" id="{F401BC43-5C36-4B0B-87DF-30223AAA2596}"/>
              </a:ext>
            </a:extLst>
          </p:cNvPr>
          <p:cNvPicPr>
            <a:picLocks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5622" y="5647584"/>
            <a:ext cx="201168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4" name="Picture 20">
            <a:extLst>
              <a:ext uri="{FF2B5EF4-FFF2-40B4-BE49-F238E27FC236}">
                <a16:creationId xmlns:a16="http://schemas.microsoft.com/office/drawing/2014/main" id="{2633D2D6-BCAE-4B1A-90DA-734D7E607D55}"/>
              </a:ext>
            </a:extLst>
          </p:cNvPr>
          <p:cNvPicPr>
            <a:picLocks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84358" y="5632750"/>
            <a:ext cx="201168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6" name="Picture 22">
            <a:extLst>
              <a:ext uri="{FF2B5EF4-FFF2-40B4-BE49-F238E27FC236}">
                <a16:creationId xmlns:a16="http://schemas.microsoft.com/office/drawing/2014/main" id="{0FEF66C4-CE27-459F-B668-89F32C4FF6E6}"/>
              </a:ext>
            </a:extLst>
          </p:cNvPr>
          <p:cNvPicPr>
            <a:picLocks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5621" y="7392358"/>
            <a:ext cx="201168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50" name="Picture 26">
            <a:extLst>
              <a:ext uri="{FF2B5EF4-FFF2-40B4-BE49-F238E27FC236}">
                <a16:creationId xmlns:a16="http://schemas.microsoft.com/office/drawing/2014/main" id="{352CABA5-FC27-436A-9447-D760B0404E51}"/>
              </a:ext>
            </a:extLst>
          </p:cNvPr>
          <p:cNvPicPr>
            <a:picLocks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84358" y="7380001"/>
            <a:ext cx="201168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9788C1EE-6036-4F61-A27C-7CACCF3C3C9C}"/>
              </a:ext>
            </a:extLst>
          </p:cNvPr>
          <p:cNvSpPr txBox="1"/>
          <p:nvPr/>
        </p:nvSpPr>
        <p:spPr>
          <a:xfrm>
            <a:off x="218713" y="6266083"/>
            <a:ext cx="19169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HepG2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EBF0A59-2F37-4A06-8DBF-9C41147191D0}"/>
              </a:ext>
            </a:extLst>
          </p:cNvPr>
          <p:cNvSpPr txBox="1"/>
          <p:nvPr/>
        </p:nvSpPr>
        <p:spPr>
          <a:xfrm>
            <a:off x="207407" y="8054122"/>
            <a:ext cx="19169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GM17212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4216263-CE99-42F1-8B31-03C591FCEE3F}"/>
              </a:ext>
            </a:extLst>
          </p:cNvPr>
          <p:cNvSpPr txBox="1"/>
          <p:nvPr/>
        </p:nvSpPr>
        <p:spPr>
          <a:xfrm>
            <a:off x="2207781" y="158290"/>
            <a:ext cx="19169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Singleton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7A46DF1-9EC4-472E-ADD7-C255DE048BF5}"/>
              </a:ext>
            </a:extLst>
          </p:cNvPr>
          <p:cNvSpPr txBox="1"/>
          <p:nvPr/>
        </p:nvSpPr>
        <p:spPr>
          <a:xfrm>
            <a:off x="4689449" y="171872"/>
            <a:ext cx="19169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Multi-DRE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B6D95DD-7CBA-4941-801F-8442501917DB}"/>
              </a:ext>
            </a:extLst>
          </p:cNvPr>
          <p:cNvSpPr txBox="1"/>
          <p:nvPr/>
        </p:nvSpPr>
        <p:spPr>
          <a:xfrm>
            <a:off x="207407" y="8723870"/>
            <a:ext cx="14911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. Fig. 1</a:t>
            </a:r>
          </a:p>
        </p:txBody>
      </p:sp>
    </p:spTree>
    <p:extLst>
      <p:ext uri="{BB962C8B-B14F-4D97-AF65-F5344CB8AC3E}">
        <p14:creationId xmlns:p14="http://schemas.microsoft.com/office/powerpoint/2010/main" val="24887390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>
            <a:extLst>
              <a:ext uri="{FF2B5EF4-FFF2-40B4-BE49-F238E27FC236}">
                <a16:creationId xmlns:a16="http://schemas.microsoft.com/office/drawing/2014/main" id="{88AD9F24-5218-44B4-91B5-1C955DC7F74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143000"/>
            <a:ext cx="6858000" cy="685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14A2F300-2937-484F-BF9E-3F89FCDABBD0}"/>
              </a:ext>
            </a:extLst>
          </p:cNvPr>
          <p:cNvSpPr txBox="1"/>
          <p:nvPr/>
        </p:nvSpPr>
        <p:spPr>
          <a:xfrm>
            <a:off x="207407" y="8723870"/>
            <a:ext cx="14911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. Fig. 2</a:t>
            </a:r>
          </a:p>
        </p:txBody>
      </p:sp>
    </p:spTree>
    <p:extLst>
      <p:ext uri="{BB962C8B-B14F-4D97-AF65-F5344CB8AC3E}">
        <p14:creationId xmlns:p14="http://schemas.microsoft.com/office/powerpoint/2010/main" val="9174662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>
            <a:extLst>
              <a:ext uri="{FF2B5EF4-FFF2-40B4-BE49-F238E27FC236}">
                <a16:creationId xmlns:a16="http://schemas.microsoft.com/office/drawing/2014/main" id="{E710C2C1-1691-433D-A7DD-12B728D2BB6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92431" y="4320552"/>
            <a:ext cx="2193341" cy="182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6" name="Picture 4">
            <a:extLst>
              <a:ext uri="{FF2B5EF4-FFF2-40B4-BE49-F238E27FC236}">
                <a16:creationId xmlns:a16="http://schemas.microsoft.com/office/drawing/2014/main" id="{0E44371B-C9DD-476F-81A6-44DD4613359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87235" y="2266242"/>
            <a:ext cx="2214242" cy="182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8" name="Picture 6">
            <a:extLst>
              <a:ext uri="{FF2B5EF4-FFF2-40B4-BE49-F238E27FC236}">
                <a16:creationId xmlns:a16="http://schemas.microsoft.com/office/drawing/2014/main" id="{1BE48AF6-C38A-4EE1-AB6F-16877F7E616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30303" y="2266242"/>
            <a:ext cx="2214242" cy="182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0" name="Picture 8">
            <a:extLst>
              <a:ext uri="{FF2B5EF4-FFF2-40B4-BE49-F238E27FC236}">
                <a16:creationId xmlns:a16="http://schemas.microsoft.com/office/drawing/2014/main" id="{FB1A9730-C991-481C-A278-EA374721B29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82804" y="6374862"/>
            <a:ext cx="2252114" cy="182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2" name="Picture 10">
            <a:extLst>
              <a:ext uri="{FF2B5EF4-FFF2-40B4-BE49-F238E27FC236}">
                <a16:creationId xmlns:a16="http://schemas.microsoft.com/office/drawing/2014/main" id="{90B342E5-AAA3-4D7E-B3C9-DC0EA268B3B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58952" y="211932"/>
            <a:ext cx="2242525" cy="182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4" name="Picture 12">
            <a:extLst>
              <a:ext uri="{FF2B5EF4-FFF2-40B4-BE49-F238E27FC236}">
                <a16:creationId xmlns:a16="http://schemas.microsoft.com/office/drawing/2014/main" id="{1B21C6C2-1271-4032-99B6-0E1C63C41AD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72452" y="211932"/>
            <a:ext cx="2242525" cy="182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013BB43-5D7F-42A7-8BA3-FF2D1EE06411}"/>
              </a:ext>
            </a:extLst>
          </p:cNvPr>
          <p:cNvSpPr txBox="1"/>
          <p:nvPr/>
        </p:nvSpPr>
        <p:spPr>
          <a:xfrm>
            <a:off x="-213774" y="847535"/>
            <a:ext cx="19169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MCF-7 45m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D727EEC-53B5-4444-B5C0-DD7BCE2FB1ED}"/>
              </a:ext>
            </a:extLst>
          </p:cNvPr>
          <p:cNvSpPr txBox="1"/>
          <p:nvPr/>
        </p:nvSpPr>
        <p:spPr>
          <a:xfrm>
            <a:off x="-191162" y="2741577"/>
            <a:ext cx="189429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Primary hepatocyte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AAF772A-78AE-4A35-B864-EE04E2A971B5}"/>
              </a:ext>
            </a:extLst>
          </p:cNvPr>
          <p:cNvSpPr txBox="1"/>
          <p:nvPr/>
        </p:nvSpPr>
        <p:spPr>
          <a:xfrm>
            <a:off x="-225276" y="4912618"/>
            <a:ext cx="1916908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US" dirty="0"/>
              <a:t>HepG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A70E83D-11FC-4AD5-879F-69F2D5581A19}"/>
              </a:ext>
            </a:extLst>
          </p:cNvPr>
          <p:cNvSpPr txBox="1"/>
          <p:nvPr/>
        </p:nvSpPr>
        <p:spPr>
          <a:xfrm>
            <a:off x="-235372" y="6877758"/>
            <a:ext cx="19169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GM1721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AE8D8DF-DB68-436F-A181-9BEA30FC2E79}"/>
              </a:ext>
            </a:extLst>
          </p:cNvPr>
          <p:cNvSpPr txBox="1"/>
          <p:nvPr/>
        </p:nvSpPr>
        <p:spPr>
          <a:xfrm>
            <a:off x="207407" y="8723870"/>
            <a:ext cx="14911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. Fig. 3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39FDA13-0041-0F7E-EDC2-D9955491C765}"/>
              </a:ext>
            </a:extLst>
          </p:cNvPr>
          <p:cNvSpPr txBox="1"/>
          <p:nvPr/>
        </p:nvSpPr>
        <p:spPr>
          <a:xfrm>
            <a:off x="1771668" y="-66955"/>
            <a:ext cx="1916908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US" dirty="0"/>
              <a:t>DMSO (VC)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A3F3D73-13CB-E568-0A23-0CF26B9D5B74}"/>
              </a:ext>
            </a:extLst>
          </p:cNvPr>
          <p:cNvSpPr txBox="1"/>
          <p:nvPr/>
        </p:nvSpPr>
        <p:spPr>
          <a:xfrm>
            <a:off x="4253336" y="-53373"/>
            <a:ext cx="1916908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US" dirty="0"/>
              <a:t>TREATED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7D238A7-D117-6119-4D79-E66F07AA487E}"/>
              </a:ext>
            </a:extLst>
          </p:cNvPr>
          <p:cNvSpPr txBox="1"/>
          <p:nvPr/>
        </p:nvSpPr>
        <p:spPr>
          <a:xfrm>
            <a:off x="1638103" y="4912618"/>
            <a:ext cx="1916908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US" dirty="0">
                <a:ea typeface="Calibri"/>
                <a:cs typeface="Calibri"/>
              </a:rPr>
              <a:t>N/A</a:t>
            </a:r>
          </a:p>
        </p:txBody>
      </p:sp>
    </p:spTree>
    <p:extLst>
      <p:ext uri="{BB962C8B-B14F-4D97-AF65-F5344CB8AC3E}">
        <p14:creationId xmlns:p14="http://schemas.microsoft.com/office/powerpoint/2010/main" val="42443529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2">
            <a:extLst>
              <a:ext uri="{FF2B5EF4-FFF2-40B4-BE49-F238E27FC236}">
                <a16:creationId xmlns:a16="http://schemas.microsoft.com/office/drawing/2014/main" id="{485E05A6-D90A-4EE4-AF8E-3AF20217F94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9865"/>
          <a:stretch/>
        </p:blipFill>
        <p:spPr bwMode="auto">
          <a:xfrm>
            <a:off x="1051516" y="790828"/>
            <a:ext cx="2690684" cy="228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2">
            <a:extLst>
              <a:ext uri="{FF2B5EF4-FFF2-40B4-BE49-F238E27FC236}">
                <a16:creationId xmlns:a16="http://schemas.microsoft.com/office/drawing/2014/main" id="{CF5D02AB-F7D7-4D0F-82A5-557DCBEA1E8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/>
          <a:stretch/>
        </p:blipFill>
        <p:spPr bwMode="auto">
          <a:xfrm>
            <a:off x="3967682" y="790828"/>
            <a:ext cx="2697956" cy="228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4">
            <a:extLst>
              <a:ext uri="{FF2B5EF4-FFF2-40B4-BE49-F238E27FC236}">
                <a16:creationId xmlns:a16="http://schemas.microsoft.com/office/drawing/2014/main" id="{1482F05D-309D-4E17-A26A-A2967A7A33C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0471"/>
          <a:stretch/>
        </p:blipFill>
        <p:spPr bwMode="auto">
          <a:xfrm>
            <a:off x="1018582" y="3617465"/>
            <a:ext cx="2723618" cy="228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4">
            <a:extLst>
              <a:ext uri="{FF2B5EF4-FFF2-40B4-BE49-F238E27FC236}">
                <a16:creationId xmlns:a16="http://schemas.microsoft.com/office/drawing/2014/main" id="{18A4FD5E-A51A-4230-BDBE-D5DD3287068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471"/>
          <a:stretch/>
        </p:blipFill>
        <p:spPr bwMode="auto">
          <a:xfrm>
            <a:off x="3967682" y="3617465"/>
            <a:ext cx="2723617" cy="228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E688808C-387D-4D0C-B73A-7DDD75AFAFBE}"/>
              </a:ext>
            </a:extLst>
          </p:cNvPr>
          <p:cNvSpPr txBox="1"/>
          <p:nvPr/>
        </p:nvSpPr>
        <p:spPr>
          <a:xfrm>
            <a:off x="-411481" y="1681727"/>
            <a:ext cx="19169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HepG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1DE050F-B36D-4917-8345-48587B655136}"/>
              </a:ext>
            </a:extLst>
          </p:cNvPr>
          <p:cNvSpPr txBox="1"/>
          <p:nvPr/>
        </p:nvSpPr>
        <p:spPr>
          <a:xfrm>
            <a:off x="-411481" y="4566581"/>
            <a:ext cx="19169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GM1721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89D7133-A46F-4E52-8718-A6C28198D41F}"/>
              </a:ext>
            </a:extLst>
          </p:cNvPr>
          <p:cNvSpPr txBox="1"/>
          <p:nvPr/>
        </p:nvSpPr>
        <p:spPr>
          <a:xfrm>
            <a:off x="207407" y="8723870"/>
            <a:ext cx="14911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. Fig. 4</a:t>
            </a:r>
          </a:p>
        </p:txBody>
      </p:sp>
    </p:spTree>
    <p:extLst>
      <p:ext uri="{BB962C8B-B14F-4D97-AF65-F5344CB8AC3E}">
        <p14:creationId xmlns:p14="http://schemas.microsoft.com/office/powerpoint/2010/main" val="81437521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33A9271-3637-1442-935F-C223372FC853}"/>
              </a:ext>
            </a:extLst>
          </p:cNvPr>
          <p:cNvSpPr txBox="1"/>
          <p:nvPr/>
        </p:nvSpPr>
        <p:spPr>
          <a:xfrm>
            <a:off x="207407" y="8723870"/>
            <a:ext cx="14911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. Fig. 5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99A82C88-A1D8-824A-A8DE-A0C75BE77DC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1158" y="3468634"/>
            <a:ext cx="5916168" cy="23603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2531398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82" name="Picture 10">
            <a:extLst>
              <a:ext uri="{FF2B5EF4-FFF2-40B4-BE49-F238E27FC236}">
                <a16:creationId xmlns:a16="http://schemas.microsoft.com/office/drawing/2014/main" id="{D24F8C17-2A4D-42F7-8CF1-BEE3C30C5B4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519708" y="3269256"/>
            <a:ext cx="1543050" cy="142769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10">
            <a:extLst>
              <a:ext uri="{FF2B5EF4-FFF2-40B4-BE49-F238E27FC236}">
                <a16:creationId xmlns:a16="http://schemas.microsoft.com/office/drawing/2014/main" id="{801F3135-FD55-4AC1-8AC7-17D3270AE5D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3686175" y="3271471"/>
            <a:ext cx="1543050" cy="142769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Picture 10">
            <a:extLst>
              <a:ext uri="{FF2B5EF4-FFF2-40B4-BE49-F238E27FC236}">
                <a16:creationId xmlns:a16="http://schemas.microsoft.com/office/drawing/2014/main" id="{F93818D4-BCA4-4F98-B818-F5C1B1259EB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5191720" y="3265795"/>
            <a:ext cx="1543050" cy="14346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B0653A09-F878-4716-BF5B-C07B7FE544F8}"/>
              </a:ext>
            </a:extLst>
          </p:cNvPr>
          <p:cNvSpPr txBox="1"/>
          <p:nvPr/>
        </p:nvSpPr>
        <p:spPr>
          <a:xfrm>
            <a:off x="1084152" y="2833306"/>
            <a:ext cx="527974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b="1" dirty="0"/>
              <a:t>MCF-7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99ACAFE-2398-470A-8E23-FEF3692C4A5D}"/>
              </a:ext>
            </a:extLst>
          </p:cNvPr>
          <p:cNvSpPr txBox="1"/>
          <p:nvPr/>
        </p:nvSpPr>
        <p:spPr>
          <a:xfrm>
            <a:off x="4200329" y="2838532"/>
            <a:ext cx="527974" cy="4040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b="1" dirty="0"/>
              <a:t>HepG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B395BB0-BDB3-4B4B-80FB-BDCEA1BCC0EE}"/>
              </a:ext>
            </a:extLst>
          </p:cNvPr>
          <p:cNvSpPr txBox="1"/>
          <p:nvPr/>
        </p:nvSpPr>
        <p:spPr>
          <a:xfrm>
            <a:off x="5630531" y="2833306"/>
            <a:ext cx="665304" cy="4040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b="1" dirty="0"/>
              <a:t>GM12878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888D895-6A42-4D9E-975F-47E18132B89C}"/>
              </a:ext>
            </a:extLst>
          </p:cNvPr>
          <p:cNvSpPr txBox="1"/>
          <p:nvPr/>
        </p:nvSpPr>
        <p:spPr>
          <a:xfrm>
            <a:off x="2332718" y="2833306"/>
            <a:ext cx="1198080" cy="4040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b="1" dirty="0"/>
              <a:t>Primary hepatocyte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76BDAE54-BD3D-47B3-8F67-207818AA8243}"/>
              </a:ext>
            </a:extLst>
          </p:cNvPr>
          <p:cNvSpPr/>
          <p:nvPr/>
        </p:nvSpPr>
        <p:spPr>
          <a:xfrm>
            <a:off x="1832373" y="3244520"/>
            <a:ext cx="230386" cy="1612702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35390596-419F-4DEB-A80D-5319E97613CF}"/>
              </a:ext>
            </a:extLst>
          </p:cNvPr>
          <p:cNvSpPr/>
          <p:nvPr/>
        </p:nvSpPr>
        <p:spPr>
          <a:xfrm>
            <a:off x="3445074" y="3164153"/>
            <a:ext cx="230386" cy="1612702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E1C3E0A3-FBF7-4F19-A160-7E31C48A1164}"/>
              </a:ext>
            </a:extLst>
          </p:cNvPr>
          <p:cNvSpPr/>
          <p:nvPr/>
        </p:nvSpPr>
        <p:spPr>
          <a:xfrm>
            <a:off x="4972051" y="3164153"/>
            <a:ext cx="230386" cy="1612702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C027FC8-EC8E-4646-9220-BA4B1E44876D}"/>
              </a:ext>
            </a:extLst>
          </p:cNvPr>
          <p:cNvSpPr txBox="1"/>
          <p:nvPr/>
        </p:nvSpPr>
        <p:spPr>
          <a:xfrm>
            <a:off x="2582466" y="3807090"/>
            <a:ext cx="584002" cy="3347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75" b="1" dirty="0"/>
              <a:t>N/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1386FA0-A6A1-4CF5-98C7-F8732D91346D}"/>
              </a:ext>
            </a:extLst>
          </p:cNvPr>
          <p:cNvSpPr txBox="1"/>
          <p:nvPr/>
        </p:nvSpPr>
        <p:spPr>
          <a:xfrm>
            <a:off x="207407" y="8723870"/>
            <a:ext cx="14911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. Fig. 6</a:t>
            </a:r>
          </a:p>
        </p:txBody>
      </p:sp>
    </p:spTree>
    <p:extLst>
      <p:ext uri="{BB962C8B-B14F-4D97-AF65-F5344CB8AC3E}">
        <p14:creationId xmlns:p14="http://schemas.microsoft.com/office/powerpoint/2010/main" val="31284879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68EFC1CEF359648BC0C8AD096DB2D41" ma:contentTypeVersion="11" ma:contentTypeDescription="Create a new document." ma:contentTypeScope="" ma:versionID="d7887009c44ecb3ea7669bb6f34dcd51">
  <xsd:schema xmlns:xsd="http://www.w3.org/2001/XMLSchema" xmlns:xs="http://www.w3.org/2001/XMLSchema" xmlns:p="http://schemas.microsoft.com/office/2006/metadata/properties" xmlns:ns3="c29a6e96-27cc-4888-9e32-aed5af49d252" xmlns:ns4="a94f2dbf-9df7-40be-9b58-819c85ef70a0" targetNamespace="http://schemas.microsoft.com/office/2006/metadata/properties" ma:root="true" ma:fieldsID="ad4c5af1ff7a7a2184ec8eeab68f5c47" ns3:_="" ns4:_="">
    <xsd:import namespace="c29a6e96-27cc-4888-9e32-aed5af49d252"/>
    <xsd:import namespace="a94f2dbf-9df7-40be-9b58-819c85ef70a0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29a6e96-27cc-4888-9e32-aed5af49d252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5" nillable="true" ma:displayName="Tags" ma:internalName="MediaServiceAutoTags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94f2dbf-9df7-40be-9b58-819c85ef70a0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4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E064125E-A87F-4BBB-AE6F-AF451517FD64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8D806190-43B2-4A0B-A8A8-9C9A5C3448B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c29a6e96-27cc-4888-9e32-aed5af49d252"/>
    <ds:schemaRef ds:uri="a94f2dbf-9df7-40be-9b58-819c85ef70a0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35538FDD-A16E-493B-9034-E78416FD5994}">
  <ds:schemaRefs>
    <ds:schemaRef ds:uri="a94f2dbf-9df7-40be-9b58-819c85ef70a0"/>
    <ds:schemaRef ds:uri="http://purl.org/dc/elements/1.1/"/>
    <ds:schemaRef ds:uri="http://schemas.microsoft.com/office/2006/documentManagement/types"/>
    <ds:schemaRef ds:uri="http://schemas.microsoft.com/office/2006/metadata/properties"/>
    <ds:schemaRef ds:uri="c29a6e96-27cc-4888-9e32-aed5af49d252"/>
    <ds:schemaRef ds:uri="http://www.w3.org/XML/1998/namespace"/>
    <ds:schemaRef ds:uri="http://purl.org/dc/terms/"/>
    <ds:schemaRef ds:uri="http://schemas.microsoft.com/office/infopath/2007/PartnerControls"/>
    <ds:schemaRef ds:uri="http://schemas.openxmlformats.org/package/2006/metadata/core-properties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8</TotalTime>
  <Words>69</Words>
  <Application>Microsoft Macintosh PowerPoint</Application>
  <PresentationFormat>Letter Paper (8.5x11 in)</PresentationFormat>
  <Paragraphs>27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ilipovic, David</dc:creator>
  <cp:lastModifiedBy>Filipovic, David</cp:lastModifiedBy>
  <cp:revision>9</cp:revision>
  <dcterms:created xsi:type="dcterms:W3CDTF">2021-11-01T05:53:51Z</dcterms:created>
  <dcterms:modified xsi:type="dcterms:W3CDTF">2022-05-13T07:31:5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68EFC1CEF359648BC0C8AD096DB2D41</vt:lpwstr>
  </property>
</Properties>
</file>